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0" r:id="rId2"/>
    <p:sldId id="263" r:id="rId3"/>
    <p:sldId id="259" r:id="rId4"/>
    <p:sldId id="258" r:id="rId5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3D9D150-F6C3-57C3-54E8-5861EC2D1037}" name="Andrea Sistenich" initials="AS" userId="S::8tb25jwfkkwwmjna@m365.rwth-aachen.de::0d62c6b1-b308-4987-8fc3-039302d5757d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we Conrath" initials="UC" lastIdx="9" clrIdx="0">
    <p:extLst>
      <p:ext uri="{19B8F6BF-5375-455C-9EA6-DF929625EA0E}">
        <p15:presenceInfo xmlns:p15="http://schemas.microsoft.com/office/powerpoint/2012/main" userId="e3247a6616b8ae58" providerId="Windows Live"/>
      </p:ext>
    </p:extLst>
  </p:cmAuthor>
  <p:cmAuthor id="2" name="Andrea Sistenich" initials="AS" lastIdx="2" clrIdx="1">
    <p:extLst>
      <p:ext uri="{19B8F6BF-5375-455C-9EA6-DF929625EA0E}">
        <p15:presenceInfo xmlns:p15="http://schemas.microsoft.com/office/powerpoint/2012/main" userId="S::8tb25jwfkkwwmjna@m365.rwth-aachen.de::0d62c6b1-b308-4987-8fc3-039302d5757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6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2235F8-B391-450B-B279-81BDC5FCE428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6E5AC9-E474-4D7B-8929-CC60F510B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773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41425"/>
            <a:ext cx="2317750" cy="33496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2005B6-3581-4CFC-A154-931CFFEB1C3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2232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6E5AC9-E474-4D7B-8929-CC60F510BEF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66662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6E5AC9-E474-4D7B-8929-CC60F510BEF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9907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887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827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117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700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224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540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815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069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579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41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218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0FB55-CC09-41BD-8D85-51E1711F7623}" type="datetimeFigureOut">
              <a:rPr lang="en-US" smtClean="0"/>
              <a:t>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51EDC-4F73-4973-ACC6-35F6DD37D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2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xmlns="" id="{2D089731-981D-C9EC-A01C-FC5828CAD1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840334"/>
              </p:ext>
            </p:extLst>
          </p:nvPr>
        </p:nvGraphicFramePr>
        <p:xfrm>
          <a:off x="1581150" y="860425"/>
          <a:ext cx="3690938" cy="2655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10" r:id="rId3" imgW="3239589" imgH="2331471" progId="Prism10.Document">
                  <p:embed/>
                </p:oleObj>
              </mc:Choice>
              <mc:Fallback>
                <p:oleObj name="Prism 10" r:id="rId3" imgW="3239589" imgH="2331471" progId="Prism10.Document">
                  <p:embed/>
                  <p:pic>
                    <p:nvPicPr>
                      <p:cNvPr id="6" name="Objekt 5">
                        <a:extLst>
                          <a:ext uri="{FF2B5EF4-FFF2-40B4-BE49-F238E27FC236}">
                            <a16:creationId xmlns:a16="http://schemas.microsoft.com/office/drawing/2014/main" xmlns="" id="{6136FD27-5D85-FE2E-6211-97A9739D88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81150" y="860425"/>
                        <a:ext cx="3690938" cy="2655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D5B33F3A-A79F-1652-89B4-87CC88A83470}"/>
              </a:ext>
            </a:extLst>
          </p:cNvPr>
          <p:cNvSpPr txBox="1"/>
          <p:nvPr/>
        </p:nvSpPr>
        <p:spPr>
          <a:xfrm>
            <a:off x="1632028" y="3620516"/>
            <a:ext cx="3351815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503194"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T5G6419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s particularly activated during priming. Five-week-old Arabidopsis plants were infiltrated on three leaves with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gCl</a:t>
            </a:r>
            <a:r>
              <a:rPr lang="en-US" sz="1200" kern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ock inoculation; -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c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or 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c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spension in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gCl</a:t>
            </a:r>
            <a:r>
              <a:rPr lang="en-US" sz="1200" kern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+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c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. Three days later, untreated leaves of both sets of plant were left untreated (- systemic rechallenge) or rechallenged by the infiltration of water (+ systemic rechallenge). Three hours later, the systemic leaves were harvested and analyzed for the express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T5G6419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Relative mRNA transcript abundance was determined by RT-qPCR and normalized to the express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N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Shown are the mean values and SD of three independent experiments, each with two plants. Statistical significance was determined using Ordinary one-way ANOVA. P &lt; 0.05.</a:t>
            </a:r>
          </a:p>
        </p:txBody>
      </p:sp>
    </p:spTree>
    <p:extLst>
      <p:ext uri="{BB962C8B-B14F-4D97-AF65-F5344CB8AC3E}">
        <p14:creationId xmlns:p14="http://schemas.microsoft.com/office/powerpoint/2010/main" val="20337689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xmlns="" id="{38B34D6E-D6F2-0453-CD6F-63FD89D848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8089470"/>
              </p:ext>
            </p:extLst>
          </p:nvPr>
        </p:nvGraphicFramePr>
        <p:xfrm>
          <a:off x="-15875" y="950913"/>
          <a:ext cx="6792913" cy="225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10" r:id="rId4" imgW="7829366" imgH="2594963" progId="Prism10.Document">
                  <p:embed/>
                </p:oleObj>
              </mc:Choice>
              <mc:Fallback>
                <p:oleObj name="Prism 10" r:id="rId4" imgW="7829366" imgH="2594963" progId="Prism10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xmlns="" id="{38B34D6E-D6F2-0453-CD6F-63FD89D848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15875" y="950913"/>
                        <a:ext cx="6792913" cy="225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34F312B3-11D6-EB81-023D-00BFF4187163}"/>
              </a:ext>
            </a:extLst>
          </p:cNvPr>
          <p:cNvSpPr txBox="1"/>
          <p:nvPr/>
        </p:nvSpPr>
        <p:spPr>
          <a:xfrm>
            <a:off x="99060" y="3102388"/>
            <a:ext cx="63017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Expression of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CCR4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(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,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T4G05540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(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B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, and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T1G66870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(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C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 is associated with priming. Experimental setup, data and statistical analyses were performed as 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Figure S1.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;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B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, P &lt; 0.05;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C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, P &lt; 0.01.</a:t>
            </a:r>
            <a:endParaRPr lang="de-D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1693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F9BD223C-66D8-2275-78ED-E13A8E1A58C5}"/>
              </a:ext>
            </a:extLst>
          </p:cNvPr>
          <p:cNvSpPr txBox="1"/>
          <p:nvPr/>
        </p:nvSpPr>
        <p:spPr>
          <a:xfrm>
            <a:off x="76200" y="4088905"/>
            <a:ext cx="671512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Readout genes of priming in Arabidopsis. Genes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T4G12500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(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,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WRKY6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B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,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WRKY53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C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,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PME17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D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,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WRKY29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E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,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NRT2.6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(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F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, and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RLP11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G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 are particularly expressed in primed leaves when these have been challenged. Experimental setup, data and statistical analyses were done as 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Figure S1.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, P &lt; 0.001;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B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;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C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;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D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;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E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, P &lt; 0.0001;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F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;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G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, P &lt; 0.05. </a:t>
            </a:r>
            <a:endParaRPr lang="de-D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xmlns="" id="{D3BB846D-C146-2293-848B-54850EFFB7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3146587"/>
              </p:ext>
            </p:extLst>
          </p:nvPr>
        </p:nvGraphicFramePr>
        <p:xfrm>
          <a:off x="-61101" y="430213"/>
          <a:ext cx="7239776" cy="3589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10" r:id="rId4" imgW="9157957" imgH="4539476" progId="Prism10.Document">
                  <p:embed/>
                </p:oleObj>
              </mc:Choice>
              <mc:Fallback>
                <p:oleObj name="Prism 10" r:id="rId4" imgW="9157957" imgH="4539476" progId="Prism10.Document">
                  <p:embed/>
                  <p:pic>
                    <p:nvPicPr>
                      <p:cNvPr id="4" name="Objekt 3">
                        <a:extLst>
                          <a:ext uri="{FF2B5EF4-FFF2-40B4-BE49-F238E27FC236}">
                            <a16:creationId xmlns:a16="http://schemas.microsoft.com/office/drawing/2014/main" xmlns="" id="{A2D54EB7-2BD5-F195-DAF1-B3CDBFC428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61101" y="430213"/>
                        <a:ext cx="7239776" cy="3589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868921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87C194CE-46AC-CCAA-81E0-7440CF839A0E}"/>
              </a:ext>
            </a:extLst>
          </p:cNvPr>
          <p:cNvSpPr txBox="1"/>
          <p:nvPr/>
        </p:nvSpPr>
        <p:spPr>
          <a:xfrm>
            <a:off x="728980" y="5548168"/>
            <a:ext cx="5119370" cy="2123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AR t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c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ux is reduced in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hl25-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GK-340D09)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pr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utant. </a:t>
            </a:r>
            <a:r>
              <a:rPr lang="en-US" sz="12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Five-week-old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lants of the wild type and the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hl25-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pr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utant were mock-inoculated or inoculated with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al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n three leav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ree days later, untreated systemic leaves of all the plants were inoculated with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ux. After another 3 days,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titer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ux in the systemic leaves was determin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b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asuring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the luminescence in disc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ken from the systemic leave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ta and SD derived from three independent experiments each with eight biological replicates consisting of three systemic leaves from an appropriately treated plant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tistical significance was tested with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ruskal-Wallis test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P &lt; 0.05.</a:t>
            </a:r>
            <a:endParaRPr lang="en-US" sz="1200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xmlns="" id="{C144A198-C88D-B3CA-A1D0-C19C504BE8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0950687"/>
              </p:ext>
            </p:extLst>
          </p:nvPr>
        </p:nvGraphicFramePr>
        <p:xfrm>
          <a:off x="728980" y="407670"/>
          <a:ext cx="5413375" cy="5118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10" r:id="rId4" imgW="6334476" imgH="5990121" progId="Prism10.Document">
                  <p:embed/>
                </p:oleObj>
              </mc:Choice>
              <mc:Fallback>
                <p:oleObj name="Prism 10" r:id="rId4" imgW="6334476" imgH="5990121" progId="Prism10.Document">
                  <p:embed/>
                  <p:pic>
                    <p:nvPicPr>
                      <p:cNvPr id="5" name="Objekt 4">
                        <a:extLst>
                          <a:ext uri="{FF2B5EF4-FFF2-40B4-BE49-F238E27FC236}">
                            <a16:creationId xmlns:a16="http://schemas.microsoft.com/office/drawing/2014/main" xmlns="" id="{D5C671A5-818B-7C6E-BD8F-35FA2A79DE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28980" y="407670"/>
                        <a:ext cx="5413375" cy="5118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95440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404</Words>
  <Application>Microsoft Office PowerPoint</Application>
  <PresentationFormat>A4 Paper (210x297 mm)</PresentationFormat>
  <Paragraphs>7</Paragraphs>
  <Slides>4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Cambria</vt:lpstr>
      <vt:lpstr>Times New Roman</vt:lpstr>
      <vt:lpstr>Office</vt:lpstr>
      <vt:lpstr>Prism 10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drea Sistenich</dc:creator>
  <cp:lastModifiedBy>Judith A.</cp:lastModifiedBy>
  <cp:revision>43</cp:revision>
  <cp:lastPrinted>2023-06-30T08:35:51Z</cp:lastPrinted>
  <dcterms:created xsi:type="dcterms:W3CDTF">2023-06-19T13:49:50Z</dcterms:created>
  <dcterms:modified xsi:type="dcterms:W3CDTF">2024-02-07T13:35:34Z</dcterms:modified>
</cp:coreProperties>
</file>